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4"/>
  </p:notesMasterIdLst>
  <p:sldIdLst>
    <p:sldId id="298" r:id="rId2"/>
    <p:sldId id="299" r:id="rId3"/>
  </p:sldIdLst>
  <p:sldSz cx="5143500" cy="9144000" type="screen16x9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20" autoAdjust="0"/>
    <p:restoredTop sz="97384" autoAdjust="0"/>
  </p:normalViewPr>
  <p:slideViewPr>
    <p:cSldViewPr snapToGrid="0">
      <p:cViewPr>
        <p:scale>
          <a:sx n="200" d="100"/>
          <a:sy n="200" d="100"/>
        </p:scale>
        <p:origin x="6228" y="-22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9" d="100"/>
        <a:sy n="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B8C2AD69-A32F-4F44-AF05-4704CC489E59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78100" y="1279525"/>
            <a:ext cx="19431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E8C8AF9B-B3C5-3C4F-A0CC-1290E95999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677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578100" y="1279525"/>
            <a:ext cx="1943100" cy="34544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C8AF9B-B3C5-3C4F-A0CC-1290E959997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6376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5763" y="1496484"/>
            <a:ext cx="4371975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2938" y="4802717"/>
            <a:ext cx="3857625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772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25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80818" y="486834"/>
            <a:ext cx="1109067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3616" y="486834"/>
            <a:ext cx="3262908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305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308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0937" y="2279653"/>
            <a:ext cx="4436269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0937" y="6119286"/>
            <a:ext cx="4436269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368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3615" y="2434167"/>
            <a:ext cx="2185988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3897" y="2434167"/>
            <a:ext cx="2185988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34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486836"/>
            <a:ext cx="4436269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4286" y="2241551"/>
            <a:ext cx="2175941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4286" y="3340100"/>
            <a:ext cx="2175941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03897" y="2241551"/>
            <a:ext cx="2186657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03897" y="3340100"/>
            <a:ext cx="2186657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391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65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786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609600"/>
            <a:ext cx="165891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86657" y="1316569"/>
            <a:ext cx="2603897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4285" y="2743200"/>
            <a:ext cx="165891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497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609600"/>
            <a:ext cx="165891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86657" y="1316569"/>
            <a:ext cx="2603897" cy="6498167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4285" y="2743200"/>
            <a:ext cx="165891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071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3616" y="486836"/>
            <a:ext cx="4436269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3616" y="2434167"/>
            <a:ext cx="4436269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3615" y="8475136"/>
            <a:ext cx="115728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70411-2CA4-5346-B14D-0106F82D4250}" type="datetimeFigureOut">
              <a:rPr kumimoji="1" lang="ja-JP" altLang="en-US" smtClean="0"/>
              <a:t>2025/4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03785" y="8475136"/>
            <a:ext cx="173593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32597" y="8475136"/>
            <a:ext cx="115728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433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BB7DBDDF-1EB6-1E45-DFF7-AAF53284C94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839" t="5285"/>
          <a:stretch/>
        </p:blipFill>
        <p:spPr>
          <a:xfrm>
            <a:off x="233363" y="2699750"/>
            <a:ext cx="2220933" cy="129903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6214E00-C0AE-196A-F592-533AC1A3BA0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397" t="5179"/>
          <a:stretch/>
        </p:blipFill>
        <p:spPr>
          <a:xfrm>
            <a:off x="246186" y="4433888"/>
            <a:ext cx="2208341" cy="1300562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91D3C009-8EC8-0F89-23A8-7B47DE41329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159" t="5141"/>
          <a:stretch/>
        </p:blipFill>
        <p:spPr>
          <a:xfrm>
            <a:off x="240506" y="962024"/>
            <a:ext cx="2213790" cy="1301083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E7C3A321-2CAC-5D51-1233-21C0A8E4E12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195" t="5141"/>
          <a:stretch/>
        </p:blipFill>
        <p:spPr>
          <a:xfrm>
            <a:off x="2762250" y="962024"/>
            <a:ext cx="2212954" cy="1301083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68530F8D-BFED-E460-FD75-80979040B14E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988" t="5006" r="-1" b="-1"/>
          <a:stretch/>
        </p:blipFill>
        <p:spPr>
          <a:xfrm>
            <a:off x="2757488" y="4431506"/>
            <a:ext cx="2217716" cy="1302944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8B9D7C06-C2FC-009B-AE6A-EE7FB00E1D5E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3195" t="5160" b="1"/>
          <a:stretch/>
        </p:blipFill>
        <p:spPr>
          <a:xfrm>
            <a:off x="2762250" y="2697955"/>
            <a:ext cx="2212954" cy="130082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1950FC5-CA08-F147-7A8F-33460D7BBB38}"/>
              </a:ext>
            </a:extLst>
          </p:cNvPr>
          <p:cNvSpPr txBox="1"/>
          <p:nvPr/>
        </p:nvSpPr>
        <p:spPr>
          <a:xfrm>
            <a:off x="168297" y="581507"/>
            <a:ext cx="2744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57FF05F-AC30-CC6B-04FD-4A78A62E6C17}"/>
              </a:ext>
            </a:extLst>
          </p:cNvPr>
          <p:cNvSpPr txBox="1"/>
          <p:nvPr/>
        </p:nvSpPr>
        <p:spPr>
          <a:xfrm>
            <a:off x="1042633" y="660835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LCA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325949A-D35D-D959-1BFD-93A7BF618892}"/>
              </a:ext>
            </a:extLst>
          </p:cNvPr>
          <p:cNvSpPr txBox="1"/>
          <p:nvPr/>
        </p:nvSpPr>
        <p:spPr>
          <a:xfrm>
            <a:off x="2689205" y="581507"/>
            <a:ext cx="2744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EB49B14-BF5F-9DE9-98B5-0EEE9775B164}"/>
              </a:ext>
            </a:extLst>
          </p:cNvPr>
          <p:cNvSpPr txBox="1"/>
          <p:nvPr/>
        </p:nvSpPr>
        <p:spPr>
          <a:xfrm>
            <a:off x="3548313" y="660835"/>
            <a:ext cx="56778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HNSC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B6DD5C2-C263-3A25-AA87-1E7056712D21}"/>
              </a:ext>
            </a:extLst>
          </p:cNvPr>
          <p:cNvSpPr txBox="1"/>
          <p:nvPr/>
        </p:nvSpPr>
        <p:spPr>
          <a:xfrm>
            <a:off x="168297" y="2317178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4AC7E5A-2BE8-B424-0B4F-34F3A618C027}"/>
              </a:ext>
            </a:extLst>
          </p:cNvPr>
          <p:cNvSpPr txBox="1"/>
          <p:nvPr/>
        </p:nvSpPr>
        <p:spPr>
          <a:xfrm>
            <a:off x="1057861" y="2398521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KIR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D456BF5-C5C8-842C-8C79-29D92BFFD3FD}"/>
              </a:ext>
            </a:extLst>
          </p:cNvPr>
          <p:cNvSpPr txBox="1"/>
          <p:nvPr/>
        </p:nvSpPr>
        <p:spPr>
          <a:xfrm>
            <a:off x="168297" y="4054617"/>
            <a:ext cx="2744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AD6937E-5C15-0007-C634-D7874ABAE918}"/>
              </a:ext>
            </a:extLst>
          </p:cNvPr>
          <p:cNvSpPr txBox="1"/>
          <p:nvPr/>
        </p:nvSpPr>
        <p:spPr>
          <a:xfrm>
            <a:off x="1121981" y="4133945"/>
            <a:ext cx="3786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57A9319-D9F0-7946-7E28-222355326B5E}"/>
              </a:ext>
            </a:extLst>
          </p:cNvPr>
          <p:cNvSpPr txBox="1"/>
          <p:nvPr/>
        </p:nvSpPr>
        <p:spPr>
          <a:xfrm>
            <a:off x="2689205" y="4054617"/>
            <a:ext cx="2664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77691D7-B4D7-6CCB-4CCC-6AFB69FBC89B}"/>
              </a:ext>
            </a:extLst>
          </p:cNvPr>
          <p:cNvSpPr txBox="1"/>
          <p:nvPr/>
        </p:nvSpPr>
        <p:spPr>
          <a:xfrm>
            <a:off x="3545107" y="4133945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KCM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32D6B63-BB24-BA26-DBE4-BC7D5E0C2703}"/>
              </a:ext>
            </a:extLst>
          </p:cNvPr>
          <p:cNvSpPr txBox="1"/>
          <p:nvPr/>
        </p:nvSpPr>
        <p:spPr>
          <a:xfrm>
            <a:off x="2689205" y="2317178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EEE7A8C-53A5-793A-A51A-66C6CB1E457E}"/>
              </a:ext>
            </a:extLst>
          </p:cNvPr>
          <p:cNvSpPr txBox="1"/>
          <p:nvPr/>
        </p:nvSpPr>
        <p:spPr>
          <a:xfrm>
            <a:off x="3559533" y="2398521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US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B03C3EE-5F7A-B847-8688-2DFCDAA7C725}"/>
              </a:ext>
            </a:extLst>
          </p:cNvPr>
          <p:cNvSpPr txBox="1"/>
          <p:nvPr/>
        </p:nvSpPr>
        <p:spPr>
          <a:xfrm>
            <a:off x="0" y="0"/>
            <a:ext cx="4091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2 Fig. Distribution of mutational signature similarity in each gene set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5305F0A-9B57-8911-AA25-50670E8A85D2}"/>
              </a:ext>
            </a:extLst>
          </p:cNvPr>
          <p:cNvSpPr txBox="1"/>
          <p:nvPr/>
        </p:nvSpPr>
        <p:spPr>
          <a:xfrm rot="16200000">
            <a:off x="2632294" y="3200088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E3F6C6A-3513-4922-5A0D-84D6CB342816}"/>
              </a:ext>
            </a:extLst>
          </p:cNvPr>
          <p:cNvSpPr txBox="1"/>
          <p:nvPr/>
        </p:nvSpPr>
        <p:spPr>
          <a:xfrm rot="16200000">
            <a:off x="77105" y="4932920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4491A29-A5D1-E816-49CE-5CFA648ECAC3}"/>
              </a:ext>
            </a:extLst>
          </p:cNvPr>
          <p:cNvSpPr txBox="1"/>
          <p:nvPr/>
        </p:nvSpPr>
        <p:spPr>
          <a:xfrm rot="16200000">
            <a:off x="2595940" y="4932921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9EB0D47-45B0-A17C-4372-978F0D493203}"/>
              </a:ext>
            </a:extLst>
          </p:cNvPr>
          <p:cNvSpPr txBox="1"/>
          <p:nvPr/>
        </p:nvSpPr>
        <p:spPr>
          <a:xfrm rot="16200000">
            <a:off x="2595941" y="3200088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26BEE59-8101-1AF5-6A87-04F6C8098157}"/>
              </a:ext>
            </a:extLst>
          </p:cNvPr>
          <p:cNvSpPr txBox="1"/>
          <p:nvPr/>
        </p:nvSpPr>
        <p:spPr>
          <a:xfrm rot="16200000">
            <a:off x="77110" y="1459811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06477A4-04D6-9735-32AD-A4C2CCAE9AF5}"/>
              </a:ext>
            </a:extLst>
          </p:cNvPr>
          <p:cNvSpPr txBox="1"/>
          <p:nvPr/>
        </p:nvSpPr>
        <p:spPr>
          <a:xfrm rot="16200000">
            <a:off x="2632297" y="1459812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91A047C-8969-247B-05AD-B6B0A9E32316}"/>
              </a:ext>
            </a:extLst>
          </p:cNvPr>
          <p:cNvSpPr txBox="1"/>
          <p:nvPr/>
        </p:nvSpPr>
        <p:spPr>
          <a:xfrm rot="16200000">
            <a:off x="2595943" y="1459806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430DB2D-6B4C-5465-66FE-9EF18D731309}"/>
              </a:ext>
            </a:extLst>
          </p:cNvPr>
          <p:cNvSpPr txBox="1"/>
          <p:nvPr/>
        </p:nvSpPr>
        <p:spPr>
          <a:xfrm rot="16200000">
            <a:off x="77110" y="3188653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</p:spTree>
    <p:extLst>
      <p:ext uri="{BB962C8B-B14F-4D97-AF65-F5344CB8AC3E}">
        <p14:creationId xmlns:p14="http://schemas.microsoft.com/office/powerpoint/2010/main" val="2785916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図 34">
            <a:extLst>
              <a:ext uri="{FF2B5EF4-FFF2-40B4-BE49-F238E27FC236}">
                <a16:creationId xmlns:a16="http://schemas.microsoft.com/office/drawing/2014/main" id="{D263AA85-DDCD-F7A1-80B3-F333EA0065B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333" t="5204"/>
          <a:stretch/>
        </p:blipFill>
        <p:spPr>
          <a:xfrm>
            <a:off x="244475" y="1423987"/>
            <a:ext cx="2209821" cy="1300217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BFA1AB78-A488-B089-E476-3E9F69C38F2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18" t="5031"/>
          <a:stretch/>
        </p:blipFill>
        <p:spPr>
          <a:xfrm>
            <a:off x="2755900" y="1421605"/>
            <a:ext cx="2219304" cy="1302599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78672989-841C-BFB2-8A0B-C5616D48FBE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054" t="5156"/>
          <a:stretch/>
        </p:blipFill>
        <p:spPr>
          <a:xfrm>
            <a:off x="238125" y="3155156"/>
            <a:ext cx="2216171" cy="1300884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C99DD91-A0C8-4FB8-FB9A-47ECB439ACCB}"/>
              </a:ext>
            </a:extLst>
          </p:cNvPr>
          <p:cNvSpPr txBox="1"/>
          <p:nvPr/>
        </p:nvSpPr>
        <p:spPr>
          <a:xfrm>
            <a:off x="146657" y="1050534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494ABC5-0ACD-4FD5-9AE9-BC65DBFB6F99}"/>
              </a:ext>
            </a:extLst>
          </p:cNvPr>
          <p:cNvSpPr txBox="1"/>
          <p:nvPr/>
        </p:nvSpPr>
        <p:spPr>
          <a:xfrm>
            <a:off x="1048243" y="112284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TAD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DFAFA5E-7AAB-1C6B-E38F-B89E38EA62DF}"/>
              </a:ext>
            </a:extLst>
          </p:cNvPr>
          <p:cNvSpPr txBox="1"/>
          <p:nvPr/>
        </p:nvSpPr>
        <p:spPr>
          <a:xfrm>
            <a:off x="2669169" y="105053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220EF0C-F029-13FF-CAC2-FB72DB4F1956}"/>
              </a:ext>
            </a:extLst>
          </p:cNvPr>
          <p:cNvSpPr txBox="1"/>
          <p:nvPr/>
        </p:nvSpPr>
        <p:spPr>
          <a:xfrm>
            <a:off x="3573159" y="1122845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TES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7EDABF4-FBD5-C936-0908-B3EB6D23AD75}"/>
              </a:ext>
            </a:extLst>
          </p:cNvPr>
          <p:cNvSpPr txBox="1"/>
          <p:nvPr/>
        </p:nvSpPr>
        <p:spPr>
          <a:xfrm>
            <a:off x="161084" y="2780055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19CD41E-966F-F877-E5EA-9E7E66ABD24F}"/>
              </a:ext>
            </a:extLst>
          </p:cNvPr>
          <p:cNvSpPr txBox="1"/>
          <p:nvPr/>
        </p:nvSpPr>
        <p:spPr>
          <a:xfrm>
            <a:off x="1037023" y="2852365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CEC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95E862C-907C-9BC5-A907-669AABF3B243}"/>
              </a:ext>
            </a:extLst>
          </p:cNvPr>
          <p:cNvSpPr txBox="1"/>
          <p:nvPr/>
        </p:nvSpPr>
        <p:spPr>
          <a:xfrm>
            <a:off x="0" y="0"/>
            <a:ext cx="11047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2 Fig. </a:t>
            </a:r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continue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A78B98-80F1-02C5-2423-91FEE9705533}"/>
              </a:ext>
            </a:extLst>
          </p:cNvPr>
          <p:cNvSpPr txBox="1"/>
          <p:nvPr/>
        </p:nvSpPr>
        <p:spPr>
          <a:xfrm rot="16200000">
            <a:off x="113461" y="3660462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6547D6B-A3A9-74E3-3BF0-4A8D4D839085}"/>
              </a:ext>
            </a:extLst>
          </p:cNvPr>
          <p:cNvSpPr txBox="1"/>
          <p:nvPr/>
        </p:nvSpPr>
        <p:spPr>
          <a:xfrm rot="16200000">
            <a:off x="113462" y="1920186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E91612D-17F2-5EFA-2A85-6CCC38936B23}"/>
              </a:ext>
            </a:extLst>
          </p:cNvPr>
          <p:cNvSpPr txBox="1"/>
          <p:nvPr/>
        </p:nvSpPr>
        <p:spPr>
          <a:xfrm rot="16200000">
            <a:off x="2632297" y="1920187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CB8D603-5842-FFAD-C39D-2C9D9E1F0A55}"/>
              </a:ext>
            </a:extLst>
          </p:cNvPr>
          <p:cNvSpPr txBox="1"/>
          <p:nvPr/>
        </p:nvSpPr>
        <p:spPr>
          <a:xfrm rot="16200000">
            <a:off x="2632295" y="1920181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2A0C510-41CE-F70C-6FF2-1C1D6242EC58}"/>
              </a:ext>
            </a:extLst>
          </p:cNvPr>
          <p:cNvSpPr txBox="1"/>
          <p:nvPr/>
        </p:nvSpPr>
        <p:spPr>
          <a:xfrm rot="16200000">
            <a:off x="113462" y="1920180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520D0B2-0245-8575-8DE3-B7BE3AFF43DA}"/>
              </a:ext>
            </a:extLst>
          </p:cNvPr>
          <p:cNvSpPr txBox="1"/>
          <p:nvPr/>
        </p:nvSpPr>
        <p:spPr>
          <a:xfrm rot="16200000">
            <a:off x="2632297" y="1920181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CC2B235-B75D-7098-5E84-E536B0DF38AB}"/>
              </a:ext>
            </a:extLst>
          </p:cNvPr>
          <p:cNvSpPr txBox="1"/>
          <p:nvPr/>
        </p:nvSpPr>
        <p:spPr>
          <a:xfrm rot="16200000">
            <a:off x="77109" y="3647761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59F96C5-B7BD-90B5-8BBE-F842EC290BA5}"/>
              </a:ext>
            </a:extLst>
          </p:cNvPr>
          <p:cNvSpPr txBox="1"/>
          <p:nvPr/>
        </p:nvSpPr>
        <p:spPr>
          <a:xfrm rot="16200000">
            <a:off x="113462" y="1917009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8F7B6D3-9B09-0BD1-EEC8-207186B48367}"/>
              </a:ext>
            </a:extLst>
          </p:cNvPr>
          <p:cNvSpPr txBox="1"/>
          <p:nvPr/>
        </p:nvSpPr>
        <p:spPr>
          <a:xfrm rot="16200000">
            <a:off x="2632297" y="1917010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8ABF0C3-0C4A-0202-ED33-C47D204F8A07}"/>
              </a:ext>
            </a:extLst>
          </p:cNvPr>
          <p:cNvSpPr txBox="1"/>
          <p:nvPr/>
        </p:nvSpPr>
        <p:spPr>
          <a:xfrm rot="16200000">
            <a:off x="2632295" y="1917004"/>
            <a:ext cx="211596" cy="5386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A87B456-7E60-A6C1-4501-0AA727B1C098}"/>
              </a:ext>
            </a:extLst>
          </p:cNvPr>
          <p:cNvSpPr txBox="1"/>
          <p:nvPr/>
        </p:nvSpPr>
        <p:spPr>
          <a:xfrm rot="16200000">
            <a:off x="77110" y="1917003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5C2AF2B-8754-0446-F614-85DCC5D834FE}"/>
              </a:ext>
            </a:extLst>
          </p:cNvPr>
          <p:cNvSpPr txBox="1"/>
          <p:nvPr/>
        </p:nvSpPr>
        <p:spPr>
          <a:xfrm rot="16200000">
            <a:off x="2595945" y="1917004"/>
            <a:ext cx="284301" cy="53861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pPr algn="ctr"/>
            <a:r>
              <a:rPr lang="en-US" altLang="ja-JP" sz="350" dirty="0">
                <a:latin typeface="Arial" panose="020B0604020202020204" pitchFamily="34" charset="0"/>
                <a:cs typeface="Arial" panose="020B0604020202020204" pitchFamily="34" charset="0"/>
              </a:rPr>
              <a:t>Dice index</a:t>
            </a:r>
          </a:p>
        </p:txBody>
      </p:sp>
    </p:spTree>
    <p:extLst>
      <p:ext uri="{BB962C8B-B14F-4D97-AF65-F5344CB8AC3E}">
        <p14:creationId xmlns:p14="http://schemas.microsoft.com/office/powerpoint/2010/main" val="3756156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9242</TotalTime>
  <Words>75</Words>
  <Application>Microsoft Office PowerPoint</Application>
  <PresentationFormat>画面に合わせる (16:9)</PresentationFormat>
  <Paragraphs>41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2013 - 2022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suke kodama</dc:creator>
  <cp:lastModifiedBy>兒玉 啓輔 / Keisuke Kodama</cp:lastModifiedBy>
  <cp:revision>99</cp:revision>
  <cp:lastPrinted>2024-09-08T22:06:42Z</cp:lastPrinted>
  <dcterms:created xsi:type="dcterms:W3CDTF">2023-09-12T02:54:47Z</dcterms:created>
  <dcterms:modified xsi:type="dcterms:W3CDTF">2025-04-07T16:04:22Z</dcterms:modified>
</cp:coreProperties>
</file>